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8"/>
  </p:notesMasterIdLst>
  <p:sldIdLst>
    <p:sldId id="360" r:id="rId5"/>
    <p:sldId id="270" r:id="rId6"/>
    <p:sldId id="257" r:id="rId7"/>
  </p:sldIdLst>
  <p:sldSz cx="6858000" cy="9144000" type="letter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D9"/>
    <a:srgbClr val="009424"/>
    <a:srgbClr val="001B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6737ED9-226C-459F-A559-8300E3F2B493}" v="8" dt="2025-07-24T14:16:00.8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097" autoAdjust="0"/>
  </p:normalViewPr>
  <p:slideViewPr>
    <p:cSldViewPr snapToGrid="0" showGuides="1">
      <p:cViewPr>
        <p:scale>
          <a:sx n="100" d="100"/>
          <a:sy n="100" d="100"/>
        </p:scale>
        <p:origin x="1666" y="-5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i, Yuguo" userId="b6998acd-6d1e-4b45-b29c-b6cf0b0f3792" providerId="ADAL" clId="{16737ED9-226C-459F-A559-8300E3F2B493}"/>
    <pc:docChg chg="undo custSel addSld delSld modSld sldOrd modNotesMaster">
      <pc:chgData name="Lei, Yuguo" userId="b6998acd-6d1e-4b45-b29c-b6cf0b0f3792" providerId="ADAL" clId="{16737ED9-226C-459F-A559-8300E3F2B493}" dt="2025-07-24T15:15:49.042" v="619" actId="20577"/>
      <pc:docMkLst>
        <pc:docMk/>
      </pc:docMkLst>
      <pc:sldChg chg="delSp modSp del mod ord">
        <pc:chgData name="Lei, Yuguo" userId="b6998acd-6d1e-4b45-b29c-b6cf0b0f3792" providerId="ADAL" clId="{16737ED9-226C-459F-A559-8300E3F2B493}" dt="2025-07-24T01:03:39.756" v="509" actId="2696"/>
        <pc:sldMkLst>
          <pc:docMk/>
          <pc:sldMk cId="789525137" sldId="256"/>
        </pc:sldMkLst>
        <pc:spChg chg="mod">
          <ac:chgData name="Lei, Yuguo" userId="b6998acd-6d1e-4b45-b29c-b6cf0b0f3792" providerId="ADAL" clId="{16737ED9-226C-459F-A559-8300E3F2B493}" dt="2025-07-24T00:49:16.230" v="88" actId="20577"/>
          <ac:spMkLst>
            <pc:docMk/>
            <pc:sldMk cId="789525137" sldId="256"/>
            <ac:spMk id="26" creationId="{A755A4AC-106C-982B-C3FC-44F9AF8D6FAE}"/>
          </ac:spMkLst>
        </pc:spChg>
        <pc:spChg chg="mod">
          <ac:chgData name="Lei, Yuguo" userId="b6998acd-6d1e-4b45-b29c-b6cf0b0f3792" providerId="ADAL" clId="{16737ED9-226C-459F-A559-8300E3F2B493}" dt="2025-07-24T00:50:16.669" v="209" actId="255"/>
          <ac:spMkLst>
            <pc:docMk/>
            <pc:sldMk cId="789525137" sldId="256"/>
            <ac:spMk id="32" creationId="{93CA9FA8-9141-1822-1157-7940314D0F4B}"/>
          </ac:spMkLst>
        </pc:spChg>
        <pc:spChg chg="mod">
          <ac:chgData name="Lei, Yuguo" userId="b6998acd-6d1e-4b45-b29c-b6cf0b0f3792" providerId="ADAL" clId="{16737ED9-226C-459F-A559-8300E3F2B493}" dt="2025-07-24T00:50:16.669" v="209" actId="255"/>
          <ac:spMkLst>
            <pc:docMk/>
            <pc:sldMk cId="789525137" sldId="256"/>
            <ac:spMk id="33" creationId="{EB1CF266-06E0-E77F-B620-90271D9D44BE}"/>
          </ac:spMkLst>
        </pc:spChg>
        <pc:spChg chg="mod">
          <ac:chgData name="Lei, Yuguo" userId="b6998acd-6d1e-4b45-b29c-b6cf0b0f3792" providerId="ADAL" clId="{16737ED9-226C-459F-A559-8300E3F2B493}" dt="2025-07-24T00:50:25.991" v="213" actId="1038"/>
          <ac:spMkLst>
            <pc:docMk/>
            <pc:sldMk cId="789525137" sldId="256"/>
            <ac:spMk id="36" creationId="{C882B3C5-22E8-65D6-9927-40CCE02CECCE}"/>
          </ac:spMkLst>
        </pc:spChg>
        <pc:spChg chg="mod">
          <ac:chgData name="Lei, Yuguo" userId="b6998acd-6d1e-4b45-b29c-b6cf0b0f3792" providerId="ADAL" clId="{16737ED9-226C-459F-A559-8300E3F2B493}" dt="2025-07-24T00:50:25.991" v="213" actId="1038"/>
          <ac:spMkLst>
            <pc:docMk/>
            <pc:sldMk cId="789525137" sldId="256"/>
            <ac:spMk id="37" creationId="{EEEAE7BC-EF42-BD55-7168-9896C7F6CE35}"/>
          </ac:spMkLst>
        </pc:spChg>
        <pc:spChg chg="mod">
          <ac:chgData name="Lei, Yuguo" userId="b6998acd-6d1e-4b45-b29c-b6cf0b0f3792" providerId="ADAL" clId="{16737ED9-226C-459F-A559-8300E3F2B493}" dt="2025-07-24T01:01:30.803" v="444" actId="20577"/>
          <ac:spMkLst>
            <pc:docMk/>
            <pc:sldMk cId="789525137" sldId="256"/>
            <ac:spMk id="39" creationId="{19EF16CD-DF15-EB65-E4AA-CBA9F4A190B5}"/>
          </ac:spMkLst>
        </pc:spChg>
        <pc:spChg chg="del mod">
          <ac:chgData name="Lei, Yuguo" userId="b6998acd-6d1e-4b45-b29c-b6cf0b0f3792" providerId="ADAL" clId="{16737ED9-226C-459F-A559-8300E3F2B493}" dt="2025-07-24T00:49:13.477" v="86" actId="478"/>
          <ac:spMkLst>
            <pc:docMk/>
            <pc:sldMk cId="789525137" sldId="256"/>
            <ac:spMk id="41" creationId="{2CDD21F4-B8BD-2F64-499E-3DC76BE4094B}"/>
          </ac:spMkLst>
        </pc:spChg>
        <pc:spChg chg="mod">
          <ac:chgData name="Lei, Yuguo" userId="b6998acd-6d1e-4b45-b29c-b6cf0b0f3792" providerId="ADAL" clId="{16737ED9-226C-459F-A559-8300E3F2B493}" dt="2025-07-24T01:01:25.994" v="441" actId="20577"/>
          <ac:spMkLst>
            <pc:docMk/>
            <pc:sldMk cId="789525137" sldId="256"/>
            <ac:spMk id="47" creationId="{877C17BB-D39A-7141-7B2B-F85AEE167689}"/>
          </ac:spMkLst>
        </pc:spChg>
        <pc:spChg chg="del mod">
          <ac:chgData name="Lei, Yuguo" userId="b6998acd-6d1e-4b45-b29c-b6cf0b0f3792" providerId="ADAL" clId="{16737ED9-226C-459F-A559-8300E3F2B493}" dt="2025-07-24T00:55:56.167" v="335" actId="478"/>
          <ac:spMkLst>
            <pc:docMk/>
            <pc:sldMk cId="789525137" sldId="256"/>
            <ac:spMk id="55" creationId="{6130526C-F704-80B9-8FEB-D61E79D6B43D}"/>
          </ac:spMkLst>
        </pc:spChg>
        <pc:grpChg chg="mod">
          <ac:chgData name="Lei, Yuguo" userId="b6998acd-6d1e-4b45-b29c-b6cf0b0f3792" providerId="ADAL" clId="{16737ED9-226C-459F-A559-8300E3F2B493}" dt="2025-07-24T00:48:35.185" v="69" actId="1076"/>
          <ac:grpSpMkLst>
            <pc:docMk/>
            <pc:sldMk cId="789525137" sldId="256"/>
            <ac:grpSpMk id="53" creationId="{78DCC468-8435-FCB3-0680-B989D0014686}"/>
          </ac:grpSpMkLst>
        </pc:grpChg>
      </pc:sldChg>
      <pc:sldChg chg="addSp delSp modSp mod">
        <pc:chgData name="Lei, Yuguo" userId="b6998acd-6d1e-4b45-b29c-b6cf0b0f3792" providerId="ADAL" clId="{16737ED9-226C-459F-A559-8300E3F2B493}" dt="2025-07-24T01:49:57.607" v="609" actId="20577"/>
        <pc:sldMkLst>
          <pc:docMk/>
          <pc:sldMk cId="2715699258" sldId="257"/>
        </pc:sldMkLst>
        <pc:spChg chg="mod">
          <ac:chgData name="Lei, Yuguo" userId="b6998acd-6d1e-4b45-b29c-b6cf0b0f3792" providerId="ADAL" clId="{16737ED9-226C-459F-A559-8300E3F2B493}" dt="2025-07-24T01:49:57.607" v="609" actId="20577"/>
          <ac:spMkLst>
            <pc:docMk/>
            <pc:sldMk cId="2715699258" sldId="257"/>
            <ac:spMk id="2" creationId="{0671CA2B-A02F-C5B8-7C82-97033B416EF1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15" creationId="{6EF8724F-6F6A-78AB-4339-FBCD20348179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16" creationId="{90840089-E4FA-F581-963C-8F74E97E55C7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17" creationId="{C95AE4F6-D6CD-5603-28CC-1B5F05F02C96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25" creationId="{313A1BDE-BA0D-8194-E4A7-BFC038AEECCF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26" creationId="{1BCE20B3-5D17-A11F-E990-2A198F28C92E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27" creationId="{922A51EB-3478-BA87-4BE9-EBE5C76EFE4B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29" creationId="{F811D4A5-2932-CD28-9589-7ACB277779B9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30" creationId="{25BBDA6E-3FDB-A963-0871-B6323E7C38C8}"/>
          </ac:spMkLst>
        </pc:spChg>
        <pc:spChg chg="mod">
          <ac:chgData name="Lei, Yuguo" userId="b6998acd-6d1e-4b45-b29c-b6cf0b0f3792" providerId="ADAL" clId="{16737ED9-226C-459F-A559-8300E3F2B493}" dt="2025-07-24T01:02:06.012" v="446"/>
          <ac:spMkLst>
            <pc:docMk/>
            <pc:sldMk cId="2715699258" sldId="257"/>
            <ac:spMk id="31" creationId="{35F7DA97-A0AC-5969-4D5D-2001709CAB3C}"/>
          </ac:spMkLst>
        </pc:spChg>
        <pc:spChg chg="add del mod">
          <ac:chgData name="Lei, Yuguo" userId="b6998acd-6d1e-4b45-b29c-b6cf0b0f3792" providerId="ADAL" clId="{16737ED9-226C-459F-A559-8300E3F2B493}" dt="2025-07-24T01:03:29.550" v="506" actId="478"/>
          <ac:spMkLst>
            <pc:docMk/>
            <pc:sldMk cId="2715699258" sldId="257"/>
            <ac:spMk id="32" creationId="{5F52F720-C629-6971-24E5-2FE2ABA0F7AA}"/>
          </ac:spMkLst>
        </pc:spChg>
        <pc:spChg chg="add mod">
          <ac:chgData name="Lei, Yuguo" userId="b6998acd-6d1e-4b45-b29c-b6cf0b0f3792" providerId="ADAL" clId="{16737ED9-226C-459F-A559-8300E3F2B493}" dt="2025-07-24T01:36:13.561" v="513" actId="20577"/>
          <ac:spMkLst>
            <pc:docMk/>
            <pc:sldMk cId="2715699258" sldId="257"/>
            <ac:spMk id="33" creationId="{A4EE1B6F-A988-C152-C552-71283F5675E9}"/>
          </ac:spMkLst>
        </pc:spChg>
        <pc:spChg chg="mod">
          <ac:chgData name="Lei, Yuguo" userId="b6998acd-6d1e-4b45-b29c-b6cf0b0f3792" providerId="ADAL" clId="{16737ED9-226C-459F-A559-8300E3F2B493}" dt="2025-07-24T01:38:07.655" v="600" actId="1036"/>
          <ac:spMkLst>
            <pc:docMk/>
            <pc:sldMk cId="2715699258" sldId="257"/>
            <ac:spMk id="51" creationId="{1196218D-DA6F-06BB-EC8A-A51E747AB617}"/>
          </ac:spMkLst>
        </pc:spChg>
        <pc:spChg chg="del mod">
          <ac:chgData name="Lei, Yuguo" userId="b6998acd-6d1e-4b45-b29c-b6cf0b0f3792" providerId="ADAL" clId="{16737ED9-226C-459F-A559-8300E3F2B493}" dt="2025-07-24T00:56:06.433" v="337" actId="478"/>
          <ac:spMkLst>
            <pc:docMk/>
            <pc:sldMk cId="2715699258" sldId="257"/>
            <ac:spMk id="52" creationId="{BE9319AA-C6A1-7C6B-6454-3B9B715CB8E9}"/>
          </ac:spMkLst>
        </pc:spChg>
        <pc:grpChg chg="mod">
          <ac:chgData name="Lei, Yuguo" userId="b6998acd-6d1e-4b45-b29c-b6cf0b0f3792" providerId="ADAL" clId="{16737ED9-226C-459F-A559-8300E3F2B493}" dt="2025-07-24T01:36:11.407" v="511" actId="164"/>
          <ac:grpSpMkLst>
            <pc:docMk/>
            <pc:sldMk cId="2715699258" sldId="257"/>
            <ac:grpSpMk id="3" creationId="{A2C2087E-BBEE-B81D-57B6-35B5103AC668}"/>
          </ac:grpSpMkLst>
        </pc:grpChg>
        <pc:grpChg chg="add mod">
          <ac:chgData name="Lei, Yuguo" userId="b6998acd-6d1e-4b45-b29c-b6cf0b0f3792" providerId="ADAL" clId="{16737ED9-226C-459F-A559-8300E3F2B493}" dt="2025-07-24T01:36:37.235" v="522" actId="1076"/>
          <ac:grpSpMkLst>
            <pc:docMk/>
            <pc:sldMk cId="2715699258" sldId="257"/>
            <ac:grpSpMk id="34" creationId="{D3A123D0-22F9-965C-995C-07BF44A97060}"/>
          </ac:grpSpMkLst>
        </pc:grpChg>
        <pc:grpChg chg="add mod">
          <ac:chgData name="Lei, Yuguo" userId="b6998acd-6d1e-4b45-b29c-b6cf0b0f3792" providerId="ADAL" clId="{16737ED9-226C-459F-A559-8300E3F2B493}" dt="2025-07-24T01:36:37.235" v="522" actId="1076"/>
          <ac:grpSpMkLst>
            <pc:docMk/>
            <pc:sldMk cId="2715699258" sldId="257"/>
            <ac:grpSpMk id="35" creationId="{1C944F2E-A0B9-1D48-1BA3-FF3C29A4F7C6}"/>
          </ac:grpSpMkLst>
        </pc:grpChg>
        <pc:grpChg chg="mod">
          <ac:chgData name="Lei, Yuguo" userId="b6998acd-6d1e-4b45-b29c-b6cf0b0f3792" providerId="ADAL" clId="{16737ED9-226C-459F-A559-8300E3F2B493}" dt="2025-07-24T01:36:03.236" v="510" actId="164"/>
          <ac:grpSpMkLst>
            <pc:docMk/>
            <pc:sldMk cId="2715699258" sldId="257"/>
            <ac:grpSpMk id="50" creationId="{8A710861-5C09-5971-0365-2EB167B33688}"/>
          </ac:grpSpMkLst>
        </pc:grpChg>
      </pc:sldChg>
      <pc:sldChg chg="delSp modSp mod ord">
        <pc:chgData name="Lei, Yuguo" userId="b6998acd-6d1e-4b45-b29c-b6cf0b0f3792" providerId="ADAL" clId="{16737ED9-226C-459F-A559-8300E3F2B493}" dt="2025-07-24T15:15:49.042" v="619" actId="20577"/>
        <pc:sldMkLst>
          <pc:docMk/>
          <pc:sldMk cId="545193202" sldId="270"/>
        </pc:sldMkLst>
        <pc:spChg chg="mod">
          <ac:chgData name="Lei, Yuguo" userId="b6998acd-6d1e-4b45-b29c-b6cf0b0f3792" providerId="ADAL" clId="{16737ED9-226C-459F-A559-8300E3F2B493}" dt="2025-07-24T15:15:49.042" v="619" actId="20577"/>
          <ac:spMkLst>
            <pc:docMk/>
            <pc:sldMk cId="545193202" sldId="270"/>
            <ac:spMk id="3" creationId="{C54D7E82-8BD0-BAB1-02F1-274F3B5A0BCC}"/>
          </ac:spMkLst>
        </pc:spChg>
        <pc:spChg chg="del">
          <ac:chgData name="Lei, Yuguo" userId="b6998acd-6d1e-4b45-b29c-b6cf0b0f3792" providerId="ADAL" clId="{16737ED9-226C-459F-A559-8300E3F2B493}" dt="2025-07-24T00:45:13.219" v="0" actId="478"/>
          <ac:spMkLst>
            <pc:docMk/>
            <pc:sldMk cId="545193202" sldId="270"/>
            <ac:spMk id="4" creationId="{B72B0953-5759-00FD-4B0E-5AFDAFFABE35}"/>
          </ac:spMkLst>
        </pc:spChg>
        <pc:grpChg chg="mod">
          <ac:chgData name="Lei, Yuguo" userId="b6998acd-6d1e-4b45-b29c-b6cf0b0f3792" providerId="ADAL" clId="{16737ED9-226C-459F-A559-8300E3F2B493}" dt="2025-07-24T00:45:35.385" v="16" actId="1036"/>
          <ac:grpSpMkLst>
            <pc:docMk/>
            <pc:sldMk cId="545193202" sldId="270"/>
            <ac:grpSpMk id="2" creationId="{AE9DA68F-103B-E70E-026E-7E73BEC2B152}"/>
          </ac:grpSpMkLst>
        </pc:grpChg>
        <pc:grpChg chg="mod">
          <ac:chgData name="Lei, Yuguo" userId="b6998acd-6d1e-4b45-b29c-b6cf0b0f3792" providerId="ADAL" clId="{16737ED9-226C-459F-A559-8300E3F2B493}" dt="2025-07-24T00:45:31.731" v="9" actId="1037"/>
          <ac:grpSpMkLst>
            <pc:docMk/>
            <pc:sldMk cId="545193202" sldId="270"/>
            <ac:grpSpMk id="49" creationId="{2DAFC3F0-5527-BABB-F83D-AC8E7683C9BD}"/>
          </ac:grpSpMkLst>
        </pc:grpChg>
      </pc:sldChg>
      <pc:sldChg chg="add">
        <pc:chgData name="Lei, Yuguo" userId="b6998acd-6d1e-4b45-b29c-b6cf0b0f3792" providerId="ADAL" clId="{16737ED9-226C-459F-A559-8300E3F2B493}" dt="2025-07-24T01:49:39.771" v="602"/>
        <pc:sldMkLst>
          <pc:docMk/>
          <pc:sldMk cId="3595159319" sldId="36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73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73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03D63E-C54C-40FD-944B-FC6E5571816A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1075" y="1163638"/>
            <a:ext cx="2355850" cy="31432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82296"/>
            <a:ext cx="5486400" cy="366733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4"/>
            <a:ext cx="2971800" cy="4673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4"/>
            <a:ext cx="2971800" cy="4673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70A9D6-42F3-4267-B71C-E82CC6C037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9310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063483-75E7-954F-8C4A-71E1B7DAD9E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3006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4376B5-A4A4-8A4E-BD2B-6830282066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EC0858-7071-9818-D2A5-C458B4DB8B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12DB19-37FB-D230-C3EB-CD62C8664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BCE446-D677-62C5-E70E-69AB773C5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ED245-D234-CF0B-E83A-16E5821EA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37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7DE9F-3843-A67D-3635-0BC77371B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369AF9-96AF-A4F5-97CF-EE5E905986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36EC53-C113-DA7F-0ED9-2B5003D87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2A0D5E-7EE2-8A53-FCD3-BBD66DE62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252CE-1568-5B57-2C2F-314A342CB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409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05F975-F918-821A-B419-2560E61EF6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101451-3393-4341-C525-A8E01FAD19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8A403-E44B-53D5-10B6-20BAF6DF1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981488-623C-ABDF-F214-48999867E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94CE1C-FFEC-5237-3A17-B703914AD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625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0B83A-463D-94F1-D72D-70D9BDA0A1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877F6F-646A-3BE5-6D36-246D55E3CB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C62950-679D-D907-E6E0-7CFAF9B69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BE056-FA48-2013-D5B1-778AF2809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F5DF83-2E95-8F87-4D1A-5FDEEA0EB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805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C9E3BB-41AE-909A-AA3C-BFFD4EF94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088E8-5DC8-FA6D-98A5-9FD46243DD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024815-12FE-3583-45B2-7D56EDAE2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A532D8-E9D0-03CA-BA5E-B997AF907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54D44E-64D1-7590-6965-1ABE21D34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131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6D85B-5591-E271-88F6-8CFF42325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6B0DFC-BAC0-8BAA-CBBA-DBBFAF7F39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EF68C5-9E64-F4A6-E186-AE25143EAE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F84933-F233-41FA-0E54-A6A5FB89AE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808C32-612B-E61F-3B38-98ECD7D83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598E8F-46E7-925F-E3F7-87592ECFB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79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31203-3908-6ED1-B014-263D9C608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31297C-B4D2-F640-AFAF-EAA1EED0C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4064D8-EFBE-5AC8-31BA-B153BB7EDA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B7866D1-D996-0BCB-1FED-0807ECE2FF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ED643E-9EA3-DFA4-0F18-2B3A67C735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F3AA4C-BF92-8E76-80D7-1DE823EBB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869187-3F94-9A32-1532-907A810F9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8E2EBB-65F2-DAA2-0C7D-F513F0FBC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776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E03391-91C8-7CC0-22E4-DF652EE3B6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CF0833-F9D6-D2E2-63CA-2D5E5BC87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21B12B-EB17-BE05-C7E1-C197066B9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19B616-0758-F1E5-72F4-6C0CD51C4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162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119DE8-6F42-443A-147F-714EC6C099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B0447B-7F00-4097-D424-CD4426B4F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9B870A-87F6-FA8C-FADA-18FF2E6F9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197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50CA7-D44C-28FF-EB70-709418462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CEAB21-1208-F51E-B795-86F3ECE17C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A3BFA7-093A-6CCC-0DC1-B58EA23C9B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D11849-B65C-5B24-8794-BC1ADE6A5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9D2A58-400D-8E2D-57AF-BEB411B5E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6D6A4E-4094-B24A-64DD-A417E0333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73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DA601-2B71-946E-CE0F-5E85CF115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3C07C8-0236-D7A3-FD3C-7DEF6B5DD9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7572BD-E291-14BD-97A7-07914E1C9E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CDC30D-43AC-AE7E-D7F0-C5C5EB2E4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E268B3-B394-B2E9-FCFA-18E90BB4A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D12BD4-2C18-C49E-23F7-D590ABFA8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221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6BFBF2-A7B3-7AA6-6295-2B2972105D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E9974D-00CF-D452-BC83-187D073C7E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4013CB-60E7-77BE-6E58-F4F217361A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C41A6E-C132-4BED-977B-2EBF153B47EE}" type="datetimeFigureOut">
              <a:rPr lang="en-US" smtClean="0"/>
              <a:t>7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AD1032-1781-48C6-6500-CA41165B3C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7FEB7C-A013-1BFD-EA0D-28EE2DFC26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87D4E2-7A04-4F31-8A04-5B2F108C9A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900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13" Type="http://schemas.openxmlformats.org/officeDocument/2006/relationships/image" Target="../media/image26.tiff"/><Relationship Id="rId3" Type="http://schemas.openxmlformats.org/officeDocument/2006/relationships/image" Target="../media/image17.png"/><Relationship Id="rId7" Type="http://schemas.openxmlformats.org/officeDocument/2006/relationships/image" Target="../media/image20.tiff"/><Relationship Id="rId12" Type="http://schemas.openxmlformats.org/officeDocument/2006/relationships/image" Target="../media/image25.tif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11" Type="http://schemas.openxmlformats.org/officeDocument/2006/relationships/image" Target="../media/image24.tiff"/><Relationship Id="rId5" Type="http://schemas.openxmlformats.org/officeDocument/2006/relationships/image" Target="../media/image18.tiff"/><Relationship Id="rId10" Type="http://schemas.openxmlformats.org/officeDocument/2006/relationships/image" Target="../media/image23.tiff"/><Relationship Id="rId4" Type="http://schemas.microsoft.com/office/2007/relationships/hdphoto" Target="../media/hdphoto1.wdp"/><Relationship Id="rId9" Type="http://schemas.openxmlformats.org/officeDocument/2006/relationships/image" Target="../media/image22.tiff"/><Relationship Id="rId14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E4E419B-81F9-11C9-FF1C-7709964CDE37}"/>
                  </a:ext>
                </a:extLst>
              </p:cNvPr>
              <p:cNvSpPr txBox="1"/>
              <p:nvPr/>
            </p:nvSpPr>
            <p:spPr>
              <a:xfrm>
                <a:off x="868663" y="4690842"/>
                <a:ext cx="5350824" cy="22277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2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1. </a:t>
                </a: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Cell size analysis procedure. </a:t>
                </a:r>
              </a:p>
              <a:p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①: Harvest spheroids</a:t>
                </a:r>
                <a:endParaRPr lang="en-US" altLang="zh-CN" sz="92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②: Dissociate spheroids into single cells</a:t>
                </a:r>
              </a:p>
              <a:p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③: Pipette the cell suspension into a hemocytometer</a:t>
                </a:r>
              </a:p>
              <a:p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④: Image cells with a phase contrast microscopy</a:t>
                </a:r>
              </a:p>
              <a:p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⑤: Analyze cell size using ImageJ</a:t>
                </a:r>
              </a:p>
              <a:p>
                <a:pPr marL="633268" lvl="1" indent="-211089">
                  <a:buFont typeface="+mj-lt"/>
                  <a:buAutoNum type="alphaLcParenR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Import phase contrast images to ImageJ</a:t>
                </a:r>
              </a:p>
              <a:p>
                <a:pPr marL="633268" lvl="1" indent="-211089">
                  <a:buFont typeface="+mj-lt"/>
                  <a:buAutoNum type="alphaLcParenR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Set scale using </a:t>
                </a:r>
                <a:r>
                  <a:rPr lang="en-US" sz="92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alyze – Set Scale</a:t>
                </a:r>
              </a:p>
              <a:p>
                <a:pPr marL="633268" lvl="1" indent="-211089">
                  <a:buFont typeface="+mj-lt"/>
                  <a:buAutoNum type="alphaLcParenR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Adjust threshold using </a:t>
                </a:r>
                <a:r>
                  <a:rPr lang="en-US" sz="92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mage – Adjust – Color Threshold</a:t>
                </a:r>
              </a:p>
              <a:p>
                <a:pPr marL="633268" lvl="1" indent="-211089">
                  <a:buFont typeface="+mj-lt"/>
                  <a:buAutoNum type="alphaLcParenR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Measure cell area using </a:t>
                </a:r>
                <a:r>
                  <a:rPr lang="en-US" sz="92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alyze – Analyze Particles</a:t>
                </a: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,</a:t>
                </a:r>
                <a:r>
                  <a:rPr lang="en-US" sz="92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setting circularity to 0.70–1.00.</a:t>
                </a:r>
              </a:p>
              <a:p>
                <a:pPr marL="633268" lvl="1" indent="-211089">
                  <a:buFont typeface="+mj-lt"/>
                  <a:buAutoNum type="alphaLcParenR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Export results to Excel and calculate cell diameter using the formula:</a:t>
                </a:r>
              </a:p>
              <a:p>
                <a:pPr lvl="1" algn="ctr"/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R </a:t>
                </a:r>
                <a14:m>
                  <m:oMath xmlns:m="http://schemas.openxmlformats.org/officeDocument/2006/math">
                    <m:r>
                      <a:rPr lang="en-US" sz="923" i="1">
                        <a:latin typeface="Cambria Math" panose="02040503050406030204" pitchFamily="18" charset="0"/>
                        <a:cs typeface="Arial" panose="020B0604020202020204" pitchFamily="34" charset="0"/>
                      </a:rPr>
                      <m:t>=2</m:t>
                    </m:r>
                    <m:r>
                      <a:rPr lang="en-US" sz="923" i="1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×</m:t>
                    </m:r>
                    <m:rad>
                      <m:radPr>
                        <m:degHide m:val="on"/>
                        <m:ctrlPr>
                          <a:rPr lang="en-US" sz="923" i="1"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radPr>
                      <m:deg/>
                      <m:e>
                        <m:f>
                          <m:fPr>
                            <m:ctrlPr>
                              <a:rPr lang="en-US" sz="923" i="1"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fPr>
                          <m:num>
                            <m:r>
                              <a:rPr lang="en-US" sz="923" i="1"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  <m:t>𝑆</m:t>
                            </m:r>
                          </m:num>
                          <m:den>
                            <m:r>
                              <a:rPr lang="en-US" sz="923" i="1"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  <a:cs typeface="Arial" panose="020B0604020202020204" pitchFamily="34" charset="0"/>
                              </a:rPr>
                              <m:t>𝜋</m:t>
                            </m:r>
                          </m:den>
                        </m:f>
                      </m:e>
                    </m:rad>
                  </m:oMath>
                </a14:m>
                <a:endParaRPr lang="en-US" sz="923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marL="1424852" lvl="3" indent="-158317">
                  <a:buFont typeface="Arial" panose="020B0604020202020204" pitchFamily="34" charset="0"/>
                  <a:buChar char="•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R: Cell diameter</a:t>
                </a:r>
              </a:p>
              <a:p>
                <a:pPr marL="1424852" lvl="3" indent="-158317">
                  <a:buFont typeface="Arial" panose="020B0604020202020204" pitchFamily="34" charset="0"/>
                  <a:buChar char="•"/>
                </a:pPr>
                <a:r>
                  <a:rPr lang="en-US" sz="923" dirty="0">
                    <a:latin typeface="Arial" panose="020B0604020202020204" pitchFamily="34" charset="0"/>
                    <a:cs typeface="Arial" panose="020B0604020202020204" pitchFamily="34" charset="0"/>
                  </a:rPr>
                  <a:t>S: Area value from ImageJ</a:t>
                </a:r>
              </a:p>
            </p:txBody>
          </p:sp>
        </mc:Choice>
        <mc:Fallback xmlns=""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E4E419B-81F9-11C9-FF1C-7709964CDE3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68663" y="4690842"/>
                <a:ext cx="5350824" cy="2227726"/>
              </a:xfrm>
              <a:prstGeom prst="rect">
                <a:avLst/>
              </a:prstGeom>
              <a:blipFill>
                <a:blip r:embed="rId3"/>
                <a:stretch>
                  <a:fillRect b="-273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15" name="Picture 14" descr="A diagram of a laboratory&#10;&#10;AI-generated content may be incorrect.">
            <a:extLst>
              <a:ext uri="{FF2B5EF4-FFF2-40B4-BE49-F238E27FC236}">
                <a16:creationId xmlns:a16="http://schemas.microsoft.com/office/drawing/2014/main" id="{D73EFA97-45CB-A363-7351-C64B13D437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13084" y="1976329"/>
            <a:ext cx="4631833" cy="2540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5159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2DAFC3F0-5527-BABB-F83D-AC8E7683C9BD}"/>
              </a:ext>
            </a:extLst>
          </p:cNvPr>
          <p:cNvGrpSpPr/>
          <p:nvPr/>
        </p:nvGrpSpPr>
        <p:grpSpPr>
          <a:xfrm>
            <a:off x="204744" y="4572000"/>
            <a:ext cx="6296112" cy="1504276"/>
            <a:chOff x="569107" y="3162455"/>
            <a:chExt cx="7721862" cy="1844918"/>
          </a:xfrm>
        </p:grpSpPr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2462B54F-6892-4D80-652E-67D19B725D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8483" y="3429000"/>
              <a:ext cx="0" cy="13716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4CDBAC45-CB0E-BEBA-4C26-E1E29E666DE8}"/>
                </a:ext>
              </a:extLst>
            </p:cNvPr>
            <p:cNvCxnSpPr>
              <a:cxnSpLocks/>
            </p:cNvCxnSpPr>
            <p:nvPr/>
          </p:nvCxnSpPr>
          <p:spPr>
            <a:xfrm>
              <a:off x="840757" y="4800600"/>
              <a:ext cx="745021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95C79ABF-6FD1-EC2F-7A12-6844991C7C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2857" y="3429000"/>
              <a:ext cx="1361941" cy="1371600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D8E73026-C59B-F175-E758-654CEF8337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79524" y="3429000"/>
              <a:ext cx="1361941" cy="137160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FB526BBE-B337-1333-7BE0-C3810033F42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66191" y="3429000"/>
              <a:ext cx="1361941" cy="1371600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88BF9C2A-F89B-7DB0-04A7-21435E2A1D1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52858" y="3429000"/>
              <a:ext cx="1361941" cy="1371600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F949D4C0-165B-4FA5-D665-FD0CA2027B3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839526" y="3429000"/>
              <a:ext cx="1361941" cy="1371600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5431C21-2D81-2B71-3651-E4685ACFE3E5}"/>
                </a:ext>
              </a:extLst>
            </p:cNvPr>
            <p:cNvSpPr txBox="1"/>
            <p:nvPr/>
          </p:nvSpPr>
          <p:spPr>
            <a:xfrm rot="16200000">
              <a:off x="452258" y="3690992"/>
              <a:ext cx="440471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DEFA39B-1024-89F2-EADE-00C0E7128176}"/>
                </a:ext>
              </a:extLst>
            </p:cNvPr>
            <p:cNvSpPr txBox="1"/>
            <p:nvPr/>
          </p:nvSpPr>
          <p:spPr>
            <a:xfrm>
              <a:off x="7225703" y="4800600"/>
              <a:ext cx="904904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exa Fluor 488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582AD25-8B5C-F55F-66C8-2E8C809FDEA7}"/>
                </a:ext>
              </a:extLst>
            </p:cNvPr>
            <p:cNvSpPr txBox="1"/>
            <p:nvPr/>
          </p:nvSpPr>
          <p:spPr>
            <a:xfrm>
              <a:off x="1238628" y="3162455"/>
              <a:ext cx="637013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Unstained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D3DD598-E2AC-4027-B05B-558723060910}"/>
                </a:ext>
              </a:extLst>
            </p:cNvPr>
            <p:cNvSpPr txBox="1"/>
            <p:nvPr/>
          </p:nvSpPr>
          <p:spPr>
            <a:xfrm>
              <a:off x="2801697" y="3162455"/>
              <a:ext cx="488933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66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77284BC-17C6-2783-DBFE-D63EB3AEA525}"/>
                </a:ext>
              </a:extLst>
            </p:cNvPr>
            <p:cNvSpPr txBox="1"/>
            <p:nvPr/>
          </p:nvSpPr>
          <p:spPr>
            <a:xfrm>
              <a:off x="4288364" y="3162455"/>
              <a:ext cx="488933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46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EBC286B-573F-6BE6-0B9B-291C79363680}"/>
                </a:ext>
              </a:extLst>
            </p:cNvPr>
            <p:cNvSpPr txBox="1"/>
            <p:nvPr/>
          </p:nvSpPr>
          <p:spPr>
            <a:xfrm>
              <a:off x="5834760" y="3162455"/>
              <a:ext cx="429702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9389AEB-CBA9-EB76-D345-600D26A7B867}"/>
                </a:ext>
              </a:extLst>
            </p:cNvPr>
            <p:cNvSpPr txBox="1"/>
            <p:nvPr/>
          </p:nvSpPr>
          <p:spPr>
            <a:xfrm>
              <a:off x="7321427" y="3162455"/>
              <a:ext cx="488933" cy="206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D106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AE9DA68F-103B-E70E-026E-7E73BEC2B152}"/>
              </a:ext>
            </a:extLst>
          </p:cNvPr>
          <p:cNvGrpSpPr/>
          <p:nvPr/>
        </p:nvGrpSpPr>
        <p:grpSpPr>
          <a:xfrm>
            <a:off x="314427" y="1599529"/>
            <a:ext cx="6052747" cy="2712002"/>
            <a:chOff x="1696685" y="251466"/>
            <a:chExt cx="7812377" cy="3500425"/>
          </a:xfrm>
        </p:grpSpPr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C1A2D4D6-972F-1A59-1BEA-6B72E08F9802}"/>
                </a:ext>
              </a:extLst>
            </p:cNvPr>
            <p:cNvGrpSpPr/>
            <p:nvPr/>
          </p:nvGrpSpPr>
          <p:grpSpPr>
            <a:xfrm>
              <a:off x="1696685" y="255141"/>
              <a:ext cx="1831385" cy="3476619"/>
              <a:chOff x="1780575" y="255141"/>
              <a:chExt cx="1831385" cy="3476619"/>
            </a:xfrm>
          </p:grpSpPr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AE50C655-3BC6-0560-C81D-18351FF571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156066" y="517120"/>
                <a:ext cx="1361941" cy="1371600"/>
              </a:xfrm>
              <a:prstGeom prst="rect">
                <a:avLst/>
              </a:prstGeom>
            </p:spPr>
          </p:pic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D1AC8142-81B9-B2D5-3DC3-3C4EC877EC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156066" y="2166457"/>
                <a:ext cx="1361941" cy="1371600"/>
              </a:xfrm>
              <a:prstGeom prst="rect">
                <a:avLst/>
              </a:prstGeom>
            </p:spPr>
          </p:pic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662BD7DE-C41E-52EF-C381-5FEF017DB79E}"/>
                  </a:ext>
                </a:extLst>
              </p:cNvPr>
              <p:cNvGrpSpPr/>
              <p:nvPr/>
            </p:nvGrpSpPr>
            <p:grpSpPr>
              <a:xfrm>
                <a:off x="1780575" y="427839"/>
                <a:ext cx="1831385" cy="3303921"/>
                <a:chOff x="1780575" y="427839"/>
                <a:chExt cx="1831385" cy="3303921"/>
              </a:xfrm>
            </p:grpSpPr>
            <p:cxnSp>
              <p:nvCxnSpPr>
                <p:cNvPr id="78" name="Straight Arrow Connector 77">
                  <a:extLst>
                    <a:ext uri="{FF2B5EF4-FFF2-40B4-BE49-F238E27FC236}">
                      <a16:creationId xmlns:a16="http://schemas.microsoft.com/office/drawing/2014/main" id="{B8325746-4E64-DD53-F84D-00C844938FE3}"/>
                    </a:ext>
                  </a:extLst>
                </p:cNvPr>
                <p:cNvCxnSpPr/>
                <p:nvPr/>
              </p:nvCxnSpPr>
              <p:spPr>
                <a:xfrm flipV="1">
                  <a:off x="2060917" y="427839"/>
                  <a:ext cx="0" cy="311021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Straight Arrow Connector 79">
                  <a:extLst>
                    <a:ext uri="{FF2B5EF4-FFF2-40B4-BE49-F238E27FC236}">
                      <a16:creationId xmlns:a16="http://schemas.microsoft.com/office/drawing/2014/main" id="{93C2C092-994C-01AD-5279-90DE1CF4446B}"/>
                    </a:ext>
                  </a:extLst>
                </p:cNvPr>
                <p:cNvCxnSpPr/>
                <p:nvPr/>
              </p:nvCxnSpPr>
              <p:spPr>
                <a:xfrm>
                  <a:off x="2060917" y="3538057"/>
                  <a:ext cx="1551043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29D5CCEA-AAA0-3949-5F33-A3D10D2A49DA}"/>
                    </a:ext>
                  </a:extLst>
                </p:cNvPr>
                <p:cNvSpPr txBox="1"/>
                <p:nvPr/>
              </p:nvSpPr>
              <p:spPr>
                <a:xfrm rot="16200000">
                  <a:off x="1662215" y="694778"/>
                  <a:ext cx="446167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1553051F-C159-7FB3-6668-69CF27C63BB3}"/>
                    </a:ext>
                  </a:extLst>
                </p:cNvPr>
                <p:cNvSpPr txBox="1"/>
                <p:nvPr/>
              </p:nvSpPr>
              <p:spPr>
                <a:xfrm>
                  <a:off x="3128032" y="3522313"/>
                  <a:ext cx="375259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FS</a:t>
                  </a:r>
                </a:p>
              </p:txBody>
            </p:sp>
          </p:grp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E57370A6-FC31-22A6-A2D9-11EA0411FD98}"/>
                  </a:ext>
                </a:extLst>
              </p:cNvPr>
              <p:cNvSpPr txBox="1"/>
              <p:nvPr/>
            </p:nvSpPr>
            <p:spPr>
              <a:xfrm>
                <a:off x="2541509" y="255141"/>
                <a:ext cx="645250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stained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B8BCA953-1A4B-8591-28CD-69A411B8A51C}"/>
                  </a:ext>
                </a:extLst>
              </p:cNvPr>
              <p:cNvSpPr txBox="1"/>
              <p:nvPr/>
            </p:nvSpPr>
            <p:spPr>
              <a:xfrm>
                <a:off x="2664940" y="1907350"/>
                <a:ext cx="435258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73</a:t>
                </a:r>
              </a:p>
            </p:txBody>
          </p:sp>
        </p:grpSp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5396619B-1AFB-60B0-FB21-1E1B75DC1017}"/>
                </a:ext>
              </a:extLst>
            </p:cNvPr>
            <p:cNvGrpSpPr/>
            <p:nvPr/>
          </p:nvGrpSpPr>
          <p:grpSpPr>
            <a:xfrm>
              <a:off x="3675729" y="251466"/>
              <a:ext cx="1830017" cy="3480294"/>
              <a:chOff x="3740577" y="251466"/>
              <a:chExt cx="1830017" cy="3480294"/>
            </a:xfrm>
          </p:grpSpPr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73D07A4E-A80B-A256-8205-25E9AE7BCB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110432" y="517120"/>
                <a:ext cx="1361941" cy="1371600"/>
              </a:xfrm>
              <a:prstGeom prst="rect">
                <a:avLst/>
              </a:prstGeom>
            </p:spPr>
          </p:pic>
          <p:pic>
            <p:nvPicPr>
              <p:cNvPr id="68" name="Picture 67">
                <a:extLst>
                  <a:ext uri="{FF2B5EF4-FFF2-40B4-BE49-F238E27FC236}">
                    <a16:creationId xmlns:a16="http://schemas.microsoft.com/office/drawing/2014/main" id="{0FBCBDDC-D6C3-F9A8-AC4B-88DC42549D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110432" y="2166457"/>
                <a:ext cx="1361941" cy="1371600"/>
              </a:xfrm>
              <a:prstGeom prst="rect">
                <a:avLst/>
              </a:prstGeom>
            </p:spPr>
          </p:pic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E1ED1687-8D60-E5F3-F128-02E8C3DA6312}"/>
                  </a:ext>
                </a:extLst>
              </p:cNvPr>
              <p:cNvGrpSpPr/>
              <p:nvPr/>
            </p:nvGrpSpPr>
            <p:grpSpPr>
              <a:xfrm>
                <a:off x="3740577" y="427839"/>
                <a:ext cx="1830017" cy="3303921"/>
                <a:chOff x="1781943" y="427839"/>
                <a:chExt cx="1830017" cy="3303921"/>
              </a:xfrm>
            </p:grpSpPr>
            <p:cxnSp>
              <p:nvCxnSpPr>
                <p:cNvPr id="85" name="Straight Arrow Connector 84">
                  <a:extLst>
                    <a:ext uri="{FF2B5EF4-FFF2-40B4-BE49-F238E27FC236}">
                      <a16:creationId xmlns:a16="http://schemas.microsoft.com/office/drawing/2014/main" id="{8BDA4718-3589-0E02-146C-5E96D26AC6CD}"/>
                    </a:ext>
                  </a:extLst>
                </p:cNvPr>
                <p:cNvCxnSpPr/>
                <p:nvPr/>
              </p:nvCxnSpPr>
              <p:spPr>
                <a:xfrm flipV="1">
                  <a:off x="2060917" y="427839"/>
                  <a:ext cx="0" cy="311021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Arrow Connector 85">
                  <a:extLst>
                    <a:ext uri="{FF2B5EF4-FFF2-40B4-BE49-F238E27FC236}">
                      <a16:creationId xmlns:a16="http://schemas.microsoft.com/office/drawing/2014/main" id="{8CA111DD-8F38-701B-5B96-04A367DD2D15}"/>
                    </a:ext>
                  </a:extLst>
                </p:cNvPr>
                <p:cNvCxnSpPr/>
                <p:nvPr/>
              </p:nvCxnSpPr>
              <p:spPr>
                <a:xfrm>
                  <a:off x="2060917" y="3538057"/>
                  <a:ext cx="1551043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DA364701-5FA6-30A5-91F4-688B9042F357}"/>
                    </a:ext>
                  </a:extLst>
                </p:cNvPr>
                <p:cNvSpPr txBox="1"/>
                <p:nvPr/>
              </p:nvSpPr>
              <p:spPr>
                <a:xfrm rot="16200000">
                  <a:off x="1663583" y="674646"/>
                  <a:ext cx="446167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26B9D47D-1AAC-FDCE-7EBA-1AA2E381B722}"/>
                    </a:ext>
                  </a:extLst>
                </p:cNvPr>
                <p:cNvSpPr txBox="1"/>
                <p:nvPr/>
              </p:nvSpPr>
              <p:spPr>
                <a:xfrm>
                  <a:off x="3128032" y="3522313"/>
                  <a:ext cx="380714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PC</a:t>
                  </a:r>
                </a:p>
              </p:txBody>
            </p:sp>
          </p:grp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EAFCC004-BAC0-398E-FFC1-2F853320A7B2}"/>
                  </a:ext>
                </a:extLst>
              </p:cNvPr>
              <p:cNvSpPr txBox="1"/>
              <p:nvPr/>
            </p:nvSpPr>
            <p:spPr>
              <a:xfrm>
                <a:off x="4456236" y="251466"/>
                <a:ext cx="645250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stained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E39EFC68-429A-BB94-A915-C747035A81C1}"/>
                  </a:ext>
                </a:extLst>
              </p:cNvPr>
              <p:cNvSpPr txBox="1"/>
              <p:nvPr/>
            </p:nvSpPr>
            <p:spPr>
              <a:xfrm>
                <a:off x="4579667" y="1906693"/>
                <a:ext cx="435258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90</a:t>
                </a:r>
              </a:p>
            </p:txBody>
          </p:sp>
        </p:grp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90AE5DC8-F186-2522-F4E5-49287F8FD192}"/>
                </a:ext>
              </a:extLst>
            </p:cNvPr>
            <p:cNvGrpSpPr/>
            <p:nvPr/>
          </p:nvGrpSpPr>
          <p:grpSpPr>
            <a:xfrm>
              <a:off x="5642868" y="252123"/>
              <a:ext cx="1833171" cy="3479637"/>
              <a:chOff x="5620502" y="252123"/>
              <a:chExt cx="1833171" cy="3479637"/>
            </a:xfrm>
          </p:grpSpPr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3563BC92-F832-8CD7-537E-21666E2367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006077" y="517120"/>
                <a:ext cx="1361941" cy="1371600"/>
              </a:xfrm>
              <a:prstGeom prst="rect">
                <a:avLst/>
              </a:prstGeom>
            </p:spPr>
          </p:pic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C77D4BB8-CB45-A90A-F184-8924A120D7F8}"/>
                  </a:ext>
                </a:extLst>
              </p:cNvPr>
              <p:cNvGrpSpPr/>
              <p:nvPr/>
            </p:nvGrpSpPr>
            <p:grpSpPr>
              <a:xfrm>
                <a:off x="5620502" y="427839"/>
                <a:ext cx="1833171" cy="3303921"/>
                <a:chOff x="1778789" y="427839"/>
                <a:chExt cx="1833171" cy="3303921"/>
              </a:xfrm>
            </p:grpSpPr>
            <p:cxnSp>
              <p:nvCxnSpPr>
                <p:cNvPr id="90" name="Straight Arrow Connector 89">
                  <a:extLst>
                    <a:ext uri="{FF2B5EF4-FFF2-40B4-BE49-F238E27FC236}">
                      <a16:creationId xmlns:a16="http://schemas.microsoft.com/office/drawing/2014/main" id="{D904B40C-C84B-B0A1-1240-E00DB246F1E0}"/>
                    </a:ext>
                  </a:extLst>
                </p:cNvPr>
                <p:cNvCxnSpPr/>
                <p:nvPr/>
              </p:nvCxnSpPr>
              <p:spPr>
                <a:xfrm flipV="1">
                  <a:off x="2060917" y="427839"/>
                  <a:ext cx="0" cy="311021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Straight Arrow Connector 90">
                  <a:extLst>
                    <a:ext uri="{FF2B5EF4-FFF2-40B4-BE49-F238E27FC236}">
                      <a16:creationId xmlns:a16="http://schemas.microsoft.com/office/drawing/2014/main" id="{971DF44D-8A55-0E9A-BDFF-7AE4A3B888A5}"/>
                    </a:ext>
                  </a:extLst>
                </p:cNvPr>
                <p:cNvCxnSpPr/>
                <p:nvPr/>
              </p:nvCxnSpPr>
              <p:spPr>
                <a:xfrm>
                  <a:off x="2060917" y="3538057"/>
                  <a:ext cx="1551043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74C6397C-7CC4-E5B2-FAE1-589D2DB0056E}"/>
                    </a:ext>
                  </a:extLst>
                </p:cNvPr>
                <p:cNvSpPr txBox="1"/>
                <p:nvPr/>
              </p:nvSpPr>
              <p:spPr>
                <a:xfrm rot="16200000">
                  <a:off x="1660429" y="674646"/>
                  <a:ext cx="446167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5C3EE7D1-0BD0-4936-2D54-DECE142C233E}"/>
                    </a:ext>
                  </a:extLst>
                </p:cNvPr>
                <p:cNvSpPr txBox="1"/>
                <p:nvPr/>
              </p:nvSpPr>
              <p:spPr>
                <a:xfrm>
                  <a:off x="3128032" y="3522313"/>
                  <a:ext cx="477529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erCP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ABB7E17C-BDBE-43E8-746D-7C7588EC8E6F}"/>
                  </a:ext>
                </a:extLst>
              </p:cNvPr>
              <p:cNvSpPr txBox="1"/>
              <p:nvPr/>
            </p:nvSpPr>
            <p:spPr>
              <a:xfrm>
                <a:off x="6323455" y="252123"/>
                <a:ext cx="645250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stained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6DEC3C12-86A6-08D2-86C7-1C8F474F2187}"/>
                  </a:ext>
                </a:extLst>
              </p:cNvPr>
              <p:cNvSpPr txBox="1"/>
              <p:nvPr/>
            </p:nvSpPr>
            <p:spPr>
              <a:xfrm>
                <a:off x="6446886" y="1907350"/>
                <a:ext cx="495256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105</a:t>
                </a:r>
              </a:p>
            </p:txBody>
          </p:sp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F2E1BCEF-F5FD-70F2-2AA9-DFA2524D68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006077" y="2166457"/>
                <a:ext cx="1361941" cy="1371600"/>
              </a:xfrm>
              <a:prstGeom prst="rect">
                <a:avLst/>
              </a:prstGeom>
            </p:spPr>
          </p:pic>
        </p:grpSp>
        <p:grpSp>
          <p:nvGrpSpPr>
            <p:cNvPr id="107" name="Group 106">
              <a:extLst>
                <a:ext uri="{FF2B5EF4-FFF2-40B4-BE49-F238E27FC236}">
                  <a16:creationId xmlns:a16="http://schemas.microsoft.com/office/drawing/2014/main" id="{01D9EBC9-6E6E-F604-1DCA-511DAB91A388}"/>
                </a:ext>
              </a:extLst>
            </p:cNvPr>
            <p:cNvGrpSpPr/>
            <p:nvPr/>
          </p:nvGrpSpPr>
          <p:grpSpPr>
            <a:xfrm>
              <a:off x="7680069" y="251466"/>
              <a:ext cx="1828993" cy="3500425"/>
              <a:chOff x="7413463" y="231335"/>
              <a:chExt cx="1828993" cy="3500425"/>
            </a:xfrm>
          </p:grpSpPr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51651B25-CB74-8D08-1971-B307E07577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7779222" y="517120"/>
                <a:ext cx="1361941" cy="1371600"/>
              </a:xfrm>
              <a:prstGeom prst="rect">
                <a:avLst/>
              </a:prstGeom>
            </p:spPr>
          </p:pic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7FA18E12-167D-4909-C14C-79141975C4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7779222" y="2166457"/>
                <a:ext cx="1361941" cy="1371600"/>
              </a:xfrm>
              <a:prstGeom prst="rect">
                <a:avLst/>
              </a:prstGeom>
            </p:spPr>
          </p:pic>
          <p:grpSp>
            <p:nvGrpSpPr>
              <p:cNvPr id="94" name="Group 93">
                <a:extLst>
                  <a:ext uri="{FF2B5EF4-FFF2-40B4-BE49-F238E27FC236}">
                    <a16:creationId xmlns:a16="http://schemas.microsoft.com/office/drawing/2014/main" id="{3044EA2B-29BC-4146-94E8-A514BC80D288}"/>
                  </a:ext>
                </a:extLst>
              </p:cNvPr>
              <p:cNvGrpSpPr/>
              <p:nvPr/>
            </p:nvGrpSpPr>
            <p:grpSpPr>
              <a:xfrm>
                <a:off x="7413463" y="427839"/>
                <a:ext cx="1828993" cy="3303921"/>
                <a:chOff x="1782967" y="427839"/>
                <a:chExt cx="1828993" cy="3303921"/>
              </a:xfrm>
            </p:grpSpPr>
            <p:cxnSp>
              <p:nvCxnSpPr>
                <p:cNvPr id="95" name="Straight Arrow Connector 94">
                  <a:extLst>
                    <a:ext uri="{FF2B5EF4-FFF2-40B4-BE49-F238E27FC236}">
                      <a16:creationId xmlns:a16="http://schemas.microsoft.com/office/drawing/2014/main" id="{53DFF36C-6916-C140-F6AD-00066639DAF4}"/>
                    </a:ext>
                  </a:extLst>
                </p:cNvPr>
                <p:cNvCxnSpPr/>
                <p:nvPr/>
              </p:nvCxnSpPr>
              <p:spPr>
                <a:xfrm flipV="1">
                  <a:off x="2060917" y="427839"/>
                  <a:ext cx="0" cy="3110218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Arrow Connector 95">
                  <a:extLst>
                    <a:ext uri="{FF2B5EF4-FFF2-40B4-BE49-F238E27FC236}">
                      <a16:creationId xmlns:a16="http://schemas.microsoft.com/office/drawing/2014/main" id="{20E022D4-5C27-A233-259E-B0DE8A21C9E5}"/>
                    </a:ext>
                  </a:extLst>
                </p:cNvPr>
                <p:cNvCxnSpPr/>
                <p:nvPr/>
              </p:nvCxnSpPr>
              <p:spPr>
                <a:xfrm>
                  <a:off x="2060917" y="3538057"/>
                  <a:ext cx="1551043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F182BC89-860A-8366-2EE6-CC7E9128FFE9}"/>
                    </a:ext>
                  </a:extLst>
                </p:cNvPr>
                <p:cNvSpPr txBox="1"/>
                <p:nvPr/>
              </p:nvSpPr>
              <p:spPr>
                <a:xfrm rot="16200000">
                  <a:off x="1664607" y="655872"/>
                  <a:ext cx="446167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98" name="TextBox 97">
                  <a:extLst>
                    <a:ext uri="{FF2B5EF4-FFF2-40B4-BE49-F238E27FC236}">
                      <a16:creationId xmlns:a16="http://schemas.microsoft.com/office/drawing/2014/main" id="{341B6B4A-4DAD-FA8D-4773-F141917F3CCB}"/>
                    </a:ext>
                  </a:extLst>
                </p:cNvPr>
                <p:cNvSpPr txBox="1"/>
                <p:nvPr/>
              </p:nvSpPr>
              <p:spPr>
                <a:xfrm>
                  <a:off x="3128032" y="3522313"/>
                  <a:ext cx="301626" cy="2094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</a:t>
                  </a:r>
                </a:p>
              </p:txBody>
            </p:sp>
          </p:grp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B2F85CCC-9A8D-D1A8-19DB-C419DE9359C2}"/>
                  </a:ext>
                </a:extLst>
              </p:cNvPr>
              <p:cNvSpPr txBox="1"/>
              <p:nvPr/>
            </p:nvSpPr>
            <p:spPr>
              <a:xfrm>
                <a:off x="7988079" y="231335"/>
                <a:ext cx="645250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stained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848FDA00-E5A3-814C-43A1-53C386FD591D}"/>
                  </a:ext>
                </a:extLst>
              </p:cNvPr>
              <p:cNvSpPr txBox="1"/>
              <p:nvPr/>
            </p:nvSpPr>
            <p:spPr>
              <a:xfrm>
                <a:off x="7833311" y="1907349"/>
                <a:ext cx="954785" cy="20944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egative marker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C54D7E82-8BD0-BAB1-02F1-274F3B5A0BCC}"/>
              </a:ext>
            </a:extLst>
          </p:cNvPr>
          <p:cNvSpPr txBox="1"/>
          <p:nvPr/>
        </p:nvSpPr>
        <p:spPr>
          <a:xfrm>
            <a:off x="357391" y="6394273"/>
            <a:ext cx="62123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istogram of mesenchymal stem cell (MSC) surface marker expression by flow cytometry. Related to Figure 1D.</a:t>
            </a:r>
          </a:p>
        </p:txBody>
      </p:sp>
    </p:spTree>
    <p:extLst>
      <p:ext uri="{BB962C8B-B14F-4D97-AF65-F5344CB8AC3E}">
        <p14:creationId xmlns:p14="http://schemas.microsoft.com/office/powerpoint/2010/main" val="5451932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D3A123D0-22F9-965C-995C-07BF44A97060}"/>
              </a:ext>
            </a:extLst>
          </p:cNvPr>
          <p:cNvGrpSpPr/>
          <p:nvPr/>
        </p:nvGrpSpPr>
        <p:grpSpPr>
          <a:xfrm>
            <a:off x="548771" y="4006217"/>
            <a:ext cx="5760458" cy="1417315"/>
            <a:chOff x="591197" y="1943536"/>
            <a:chExt cx="5760458" cy="1417315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8A710861-5C09-5971-0365-2EB167B33688}"/>
                </a:ext>
              </a:extLst>
            </p:cNvPr>
            <p:cNvGrpSpPr/>
            <p:nvPr/>
          </p:nvGrpSpPr>
          <p:grpSpPr>
            <a:xfrm>
              <a:off x="668545" y="2030128"/>
              <a:ext cx="5683110" cy="1330723"/>
              <a:chOff x="1016980" y="2492242"/>
              <a:chExt cx="5683110" cy="1330723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CAED682F-29CD-7DAE-A475-0F2FEA83E2A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413286" y="2817125"/>
                <a:ext cx="1347592" cy="1005840"/>
              </a:xfrm>
              <a:prstGeom prst="rect">
                <a:avLst/>
              </a:prstGeom>
            </p:spPr>
          </p:pic>
          <p:cxnSp>
            <p:nvCxnSpPr>
              <p:cNvPr id="22" name="Google Shape;162;p2">
                <a:extLst>
                  <a:ext uri="{FF2B5EF4-FFF2-40B4-BE49-F238E27FC236}">
                    <a16:creationId xmlns:a16="http://schemas.microsoft.com/office/drawing/2014/main" id="{559F5AEF-5416-D02E-4F03-3AC6757AB1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2381" y="2714912"/>
                <a:ext cx="2690002" cy="0"/>
              </a:xfrm>
              <a:prstGeom prst="straightConnector1">
                <a:avLst/>
              </a:prstGeom>
              <a:noFill/>
              <a:ln w="158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23" name="Google Shape;114;p1">
                <a:extLst>
                  <a:ext uri="{FF2B5EF4-FFF2-40B4-BE49-F238E27FC236}">
                    <a16:creationId xmlns:a16="http://schemas.microsoft.com/office/drawing/2014/main" id="{681FA6E7-7E29-A4E8-3C7A-F5BC6B16E4F7}"/>
                  </a:ext>
                </a:extLst>
              </p:cNvPr>
              <p:cNvSpPr txBox="1"/>
              <p:nvPr/>
            </p:nvSpPr>
            <p:spPr>
              <a:xfrm>
                <a:off x="1951081" y="2492242"/>
                <a:ext cx="872601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Adipocytes</a:t>
                </a:r>
                <a:endParaRPr dirty="0"/>
              </a:p>
            </p:txBody>
          </p:sp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170E1D12-7B78-D644-5077-9FF1EAB07B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016980" y="2817125"/>
                <a:ext cx="1342410" cy="1005840"/>
              </a:xfrm>
              <a:prstGeom prst="rect">
                <a:avLst/>
              </a:prstGeom>
            </p:spPr>
          </p:pic>
          <p:pic>
            <p:nvPicPr>
              <p:cNvPr id="40" name="Picture 39" descr="A green glowing cells in a dark background&#10;&#10;AI-generated content may be incorrect.">
                <a:extLst>
                  <a:ext uri="{FF2B5EF4-FFF2-40B4-BE49-F238E27FC236}">
                    <a16:creationId xmlns:a16="http://schemas.microsoft.com/office/drawing/2014/main" id="{0CE969AC-1885-EF8A-BE09-AA9F6740D1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98602" y="2817125"/>
                <a:ext cx="1344996" cy="1005840"/>
              </a:xfrm>
              <a:prstGeom prst="rect">
                <a:avLst/>
              </a:prstGeom>
            </p:spPr>
          </p:pic>
          <p:pic>
            <p:nvPicPr>
              <p:cNvPr id="42" name="Picture 41" descr="A black and white image of a black and white image of a black and white image of a black and white image of a black and white image of a black and white image of a black and&#10;&#10;AI-generated content may be incorrect.">
                <a:extLst>
                  <a:ext uri="{FF2B5EF4-FFF2-40B4-BE49-F238E27FC236}">
                    <a16:creationId xmlns:a16="http://schemas.microsoft.com/office/drawing/2014/main" id="{5358884D-A7B8-420A-20AC-E3F9E6426E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97114" y="2817125"/>
                <a:ext cx="1344996" cy="1005840"/>
              </a:xfrm>
              <a:prstGeom prst="rect">
                <a:avLst/>
              </a:prstGeom>
            </p:spPr>
          </p:pic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34A66082-309E-8E5E-F63B-1E1AC2D0DDAD}"/>
                  </a:ext>
                </a:extLst>
              </p:cNvPr>
              <p:cNvSpPr txBox="1"/>
              <p:nvPr/>
            </p:nvSpPr>
            <p:spPr>
              <a:xfrm>
                <a:off x="5524972" y="2774140"/>
                <a:ext cx="872601" cy="2542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steocalcin 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9D73F3E4-0F0C-46E4-AEBA-2FFEFE52AB0F}"/>
                  </a:ext>
                </a:extLst>
              </p:cNvPr>
              <p:cNvSpPr txBox="1"/>
              <p:nvPr/>
            </p:nvSpPr>
            <p:spPr>
              <a:xfrm>
                <a:off x="4251525" y="2774140"/>
                <a:ext cx="73568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b="1">
                    <a:latin typeface="Arial" panose="020B0604020202020204" pitchFamily="34" charset="0"/>
                    <a:cs typeface="Arial" panose="020B0604020202020204" pitchFamily="34" charset="0"/>
                  </a:rPr>
                  <a:t>Phase</a:t>
                </a:r>
              </a:p>
            </p:txBody>
          </p:sp>
          <p:cxnSp>
            <p:nvCxnSpPr>
              <p:cNvPr id="45" name="Google Shape;162;p2">
                <a:extLst>
                  <a:ext uri="{FF2B5EF4-FFF2-40B4-BE49-F238E27FC236}">
                    <a16:creationId xmlns:a16="http://schemas.microsoft.com/office/drawing/2014/main" id="{06383777-FD26-DD1A-42B0-7D3074DFC9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97114" y="2714912"/>
                <a:ext cx="2727762" cy="0"/>
              </a:xfrm>
              <a:prstGeom prst="straightConnector1">
                <a:avLst/>
              </a:prstGeom>
              <a:noFill/>
              <a:ln w="158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46" name="Google Shape;114;p1">
                <a:extLst>
                  <a:ext uri="{FF2B5EF4-FFF2-40B4-BE49-F238E27FC236}">
                    <a16:creationId xmlns:a16="http://schemas.microsoft.com/office/drawing/2014/main" id="{65FEBF3C-45FC-1BED-D79F-DFF492F936A3}"/>
                  </a:ext>
                </a:extLst>
              </p:cNvPr>
              <p:cNvSpPr txBox="1"/>
              <p:nvPr/>
            </p:nvSpPr>
            <p:spPr>
              <a:xfrm>
                <a:off x="4862301" y="2492242"/>
                <a:ext cx="872601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Osteocytes</a:t>
                </a:r>
                <a:endParaRPr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A70DE26-D01F-E3F5-AB90-A9A57D468982}"/>
                  </a:ext>
                </a:extLst>
              </p:cNvPr>
              <p:cNvSpPr txBox="1"/>
              <p:nvPr/>
            </p:nvSpPr>
            <p:spPr>
              <a:xfrm>
                <a:off x="2780050" y="2774141"/>
                <a:ext cx="601446" cy="254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ABP-4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3564E638-CFA5-D592-8877-CD4909EDD132}"/>
                  </a:ext>
                </a:extLst>
              </p:cNvPr>
              <p:cNvSpPr txBox="1"/>
              <p:nvPr/>
            </p:nvSpPr>
            <p:spPr>
              <a:xfrm>
                <a:off x="1473520" y="2774140"/>
                <a:ext cx="524503" cy="25421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hase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7EF46D5F-8FBB-DB7E-1ACD-96BF053C388D}"/>
                  </a:ext>
                </a:extLst>
              </p:cNvPr>
              <p:cNvSpPr txBox="1"/>
              <p:nvPr/>
            </p:nvSpPr>
            <p:spPr>
              <a:xfrm>
                <a:off x="6188411" y="3585694"/>
                <a:ext cx="511679" cy="237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μm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1932D655-5D55-5EF2-CF2D-D514851A65F4}"/>
                  </a:ext>
                </a:extLst>
              </p:cNvPr>
              <p:cNvCxnSpPr/>
              <p:nvPr/>
            </p:nvCxnSpPr>
            <p:spPr>
              <a:xfrm>
                <a:off x="6352488" y="3780577"/>
                <a:ext cx="18288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196218D-DA6F-06BB-EC8A-A51E747AB617}"/>
                </a:ext>
              </a:extLst>
            </p:cNvPr>
            <p:cNvSpPr txBox="1"/>
            <p:nvPr/>
          </p:nvSpPr>
          <p:spPr>
            <a:xfrm>
              <a:off x="591197" y="1943536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671CA2B-A02F-C5B8-7C82-97033B416EF1}"/>
              </a:ext>
            </a:extLst>
          </p:cNvPr>
          <p:cNvSpPr txBox="1"/>
          <p:nvPr/>
        </p:nvSpPr>
        <p:spPr>
          <a:xfrm>
            <a:off x="395444" y="5949202"/>
            <a:ext cx="622161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 Representative fluorescence images showing senescence-associated β-galactosidase (β-gal) activity at passages 5 (P5) and 15 (P15) under 2D and alternating 2D/3D culture conditions. (B) Differentiation of MSCs (P15) cultured via the alternating 2D/3D method into adipocytes (FABP-4⁺) and osteocytes (osteocalcin⁺). Related to Figure 6.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1C944F2E-A0B9-1D48-1BA3-FF3C29A4F7C6}"/>
              </a:ext>
            </a:extLst>
          </p:cNvPr>
          <p:cNvGrpSpPr/>
          <p:nvPr/>
        </p:nvGrpSpPr>
        <p:grpSpPr>
          <a:xfrm>
            <a:off x="297682" y="1043601"/>
            <a:ext cx="6070530" cy="2481983"/>
            <a:chOff x="313811" y="3513347"/>
            <a:chExt cx="6070530" cy="248198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A2C2087E-BBEE-B81D-57B6-35B5103AC668}"/>
                </a:ext>
              </a:extLst>
            </p:cNvPr>
            <p:cNvGrpSpPr/>
            <p:nvPr/>
          </p:nvGrpSpPr>
          <p:grpSpPr>
            <a:xfrm>
              <a:off x="313811" y="3513347"/>
              <a:ext cx="6070530" cy="2481983"/>
              <a:chOff x="243768" y="563681"/>
              <a:chExt cx="6070530" cy="2481983"/>
            </a:xfrm>
          </p:grpSpPr>
          <p:pic>
            <p:nvPicPr>
              <p:cNvPr id="4" name="Picture 3" descr="Blue lights in the dark&#10;&#10;AI-generated content may be incorrect.">
                <a:extLst>
                  <a:ext uri="{FF2B5EF4-FFF2-40B4-BE49-F238E27FC236}">
                    <a16:creationId xmlns:a16="http://schemas.microsoft.com/office/drawing/2014/main" id="{F7924FC1-F1B9-DB85-947D-7DE78DF655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8882" y="893550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5" name="Picture 4" descr="Blue lights in the dark&#10;&#10;AI-generated content may be incorrect.">
                <a:extLst>
                  <a:ext uri="{FF2B5EF4-FFF2-40B4-BE49-F238E27FC236}">
                    <a16:creationId xmlns:a16="http://schemas.microsoft.com/office/drawing/2014/main" id="{1AD082E4-4862-1AE7-BE31-DB85C3785E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10798" y="893550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6" name="Picture 5" descr="A blue and green cells&#10;&#10;AI-generated content may be incorrect.">
                <a:extLst>
                  <a:ext uri="{FF2B5EF4-FFF2-40B4-BE49-F238E27FC236}">
                    <a16:creationId xmlns:a16="http://schemas.microsoft.com/office/drawing/2014/main" id="{FF9C8D72-D66B-32FF-C5E8-1B753586845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12555" y="2039824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7" name="Picture 6" descr="Blue and green circles in a dark background&#10;&#10;AI-generated content may be incorrect.">
                <a:extLst>
                  <a:ext uri="{FF2B5EF4-FFF2-40B4-BE49-F238E27FC236}">
                    <a16:creationId xmlns:a16="http://schemas.microsoft.com/office/drawing/2014/main" id="{B37E1633-3E50-BA28-D952-9E75EC1653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10798" y="2039824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8" name="Picture 7" descr="Blue dots in the sky&#10;&#10;AI-generated content may be incorrect.">
                <a:extLst>
                  <a:ext uri="{FF2B5EF4-FFF2-40B4-BE49-F238E27FC236}">
                    <a16:creationId xmlns:a16="http://schemas.microsoft.com/office/drawing/2014/main" id="{70CCE687-90A7-8919-EB52-931D207E69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9068" y="893550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9" name="Picture 8" descr="Blue dots in the dark&#10;&#10;AI-generated content may be incorrect.">
                <a:extLst>
                  <a:ext uri="{FF2B5EF4-FFF2-40B4-BE49-F238E27FC236}">
                    <a16:creationId xmlns:a16="http://schemas.microsoft.com/office/drawing/2014/main" id="{935FDACA-4FED-B1EB-BF28-6E43F987549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6263" y="893550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11" name="Picture 10" descr="A green and blue light&#10;&#10;AI-generated content may be incorrect.">
                <a:extLst>
                  <a:ext uri="{FF2B5EF4-FFF2-40B4-BE49-F238E27FC236}">
                    <a16:creationId xmlns:a16="http://schemas.microsoft.com/office/drawing/2014/main" id="{5AF41530-C3A6-0DF6-C9B3-4CF4586D64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7150" y="2039824"/>
                <a:ext cx="1337436" cy="1005840"/>
              </a:xfrm>
              <a:prstGeom prst="rect">
                <a:avLst/>
              </a:prstGeom>
            </p:spPr>
          </p:pic>
          <p:pic>
            <p:nvPicPr>
              <p:cNvPr id="12" name="Picture 11" descr="A close up of blue dots&#10;&#10;AI-generated content may be incorrect.">
                <a:extLst>
                  <a:ext uri="{FF2B5EF4-FFF2-40B4-BE49-F238E27FC236}">
                    <a16:creationId xmlns:a16="http://schemas.microsoft.com/office/drawing/2014/main" id="{B8DB7667-3F73-580C-C4B4-0EB25BB4860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37650" y="2039824"/>
                <a:ext cx="1337436" cy="1005840"/>
              </a:xfrm>
              <a:prstGeom prst="rect">
                <a:avLst/>
              </a:prstGeom>
            </p:spPr>
          </p:pic>
          <p:cxnSp>
            <p:nvCxnSpPr>
              <p:cNvPr id="13" name="Google Shape;162;p2">
                <a:extLst>
                  <a:ext uri="{FF2B5EF4-FFF2-40B4-BE49-F238E27FC236}">
                    <a16:creationId xmlns:a16="http://schemas.microsoft.com/office/drawing/2014/main" id="{92F24581-70BA-06EA-9D62-3BF16F010D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9585" y="811488"/>
                <a:ext cx="2690002" cy="0"/>
              </a:xfrm>
              <a:prstGeom prst="straightConnector1">
                <a:avLst/>
              </a:prstGeom>
              <a:noFill/>
              <a:ln w="158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4" name="Google Shape;162;p2">
                <a:extLst>
                  <a:ext uri="{FF2B5EF4-FFF2-40B4-BE49-F238E27FC236}">
                    <a16:creationId xmlns:a16="http://schemas.microsoft.com/office/drawing/2014/main" id="{BAB2A47D-3C3E-0357-36DF-B64FF9D434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8882" y="811488"/>
                <a:ext cx="2690002" cy="0"/>
              </a:xfrm>
              <a:prstGeom prst="straightConnector1">
                <a:avLst/>
              </a:prstGeom>
              <a:noFill/>
              <a:ln w="158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" name="Google Shape;114;p1">
                <a:extLst>
                  <a:ext uri="{FF2B5EF4-FFF2-40B4-BE49-F238E27FC236}">
                    <a16:creationId xmlns:a16="http://schemas.microsoft.com/office/drawing/2014/main" id="{6EF8724F-6F6A-78AB-4339-FBCD20348179}"/>
                  </a:ext>
                </a:extLst>
              </p:cNvPr>
              <p:cNvSpPr txBox="1"/>
              <p:nvPr/>
            </p:nvSpPr>
            <p:spPr>
              <a:xfrm>
                <a:off x="1612231" y="563681"/>
                <a:ext cx="872601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2D</a:t>
                </a:r>
                <a:endParaRPr dirty="0"/>
              </a:p>
            </p:txBody>
          </p:sp>
          <p:sp>
            <p:nvSpPr>
              <p:cNvPr id="16" name="Google Shape;114;p1">
                <a:extLst>
                  <a:ext uri="{FF2B5EF4-FFF2-40B4-BE49-F238E27FC236}">
                    <a16:creationId xmlns:a16="http://schemas.microsoft.com/office/drawing/2014/main" id="{90840089-E4FA-F581-963C-8F74E97E55C7}"/>
                  </a:ext>
                </a:extLst>
              </p:cNvPr>
              <p:cNvSpPr txBox="1"/>
              <p:nvPr/>
            </p:nvSpPr>
            <p:spPr>
              <a:xfrm>
                <a:off x="4413690" y="592541"/>
                <a:ext cx="872601" cy="23079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9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2D/3</a:t>
                </a:r>
                <a:r>
                  <a:rPr lang="en-US" altLang="zh-CN" sz="900" b="1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D</a:t>
                </a:r>
                <a:endParaRPr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95AE4F6-D6CD-5603-28CC-1B5F05F02C96}"/>
                  </a:ext>
                </a:extLst>
              </p:cNvPr>
              <p:cNvSpPr txBox="1"/>
              <p:nvPr/>
            </p:nvSpPr>
            <p:spPr>
              <a:xfrm>
                <a:off x="5802619" y="2783569"/>
                <a:ext cx="511679" cy="237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μm</a:t>
                </a:r>
                <a:endParaRPr lang="en-US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BACE5A79-8743-095E-0E7C-66738C01964B}"/>
                  </a:ext>
                </a:extLst>
              </p:cNvPr>
              <p:cNvCxnSpPr/>
              <p:nvPr/>
            </p:nvCxnSpPr>
            <p:spPr>
              <a:xfrm>
                <a:off x="5966696" y="2978452"/>
                <a:ext cx="18288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446ED374-2C73-A938-D263-C6036F9C1F2A}"/>
                  </a:ext>
                </a:extLst>
              </p:cNvPr>
              <p:cNvGrpSpPr/>
              <p:nvPr/>
            </p:nvGrpSpPr>
            <p:grpSpPr>
              <a:xfrm>
                <a:off x="586389" y="878069"/>
                <a:ext cx="490840" cy="566743"/>
                <a:chOff x="542646" y="2862113"/>
                <a:chExt cx="490840" cy="566743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25BBDA6E-3FDB-A963-0871-B6323E7C38C8}"/>
                    </a:ext>
                  </a:extLst>
                </p:cNvPr>
                <p:cNvSpPr txBox="1"/>
                <p:nvPr/>
              </p:nvSpPr>
              <p:spPr>
                <a:xfrm>
                  <a:off x="542646" y="2862113"/>
                  <a:ext cx="4908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solidFill>
                        <a:srgbClr val="0000D9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US" sz="1000" b="1" dirty="0">
                    <a:solidFill>
                      <a:srgbClr val="0000D9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35F7DA97-A0AC-5969-4D5D-2001709CAB3C}"/>
                    </a:ext>
                  </a:extLst>
                </p:cNvPr>
                <p:cNvSpPr txBox="1"/>
                <p:nvPr/>
              </p:nvSpPr>
              <p:spPr>
                <a:xfrm>
                  <a:off x="542646" y="3028746"/>
                  <a:ext cx="490840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000" b="1" dirty="0">
                      <a:solidFill>
                        <a:srgbClr val="00942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1000" b="1" dirty="0">
                      <a:solidFill>
                        <a:srgbClr val="00942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gal</a:t>
                  </a:r>
                </a:p>
                <a:p>
                  <a:endParaRPr lang="en-US" sz="1000" b="1" dirty="0">
                    <a:solidFill>
                      <a:srgbClr val="009424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47C01DE0-67A1-8536-D579-DB0299C4E89F}"/>
                  </a:ext>
                </a:extLst>
              </p:cNvPr>
              <p:cNvGrpSpPr/>
              <p:nvPr/>
            </p:nvGrpSpPr>
            <p:grpSpPr>
              <a:xfrm>
                <a:off x="3467924" y="852668"/>
                <a:ext cx="490840" cy="566743"/>
                <a:chOff x="517245" y="2836712"/>
                <a:chExt cx="490840" cy="566743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922A51EB-3478-BA87-4BE9-EBE5C76EFE4B}"/>
                    </a:ext>
                  </a:extLst>
                </p:cNvPr>
                <p:cNvSpPr txBox="1"/>
                <p:nvPr/>
              </p:nvSpPr>
              <p:spPr>
                <a:xfrm>
                  <a:off x="517245" y="2836712"/>
                  <a:ext cx="4908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solidFill>
                        <a:srgbClr val="0000D9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US" sz="1000" b="1" dirty="0">
                    <a:solidFill>
                      <a:srgbClr val="0000D9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F811D4A5-2932-CD28-9589-7ACB277779B9}"/>
                    </a:ext>
                  </a:extLst>
                </p:cNvPr>
                <p:cNvSpPr txBox="1"/>
                <p:nvPr/>
              </p:nvSpPr>
              <p:spPr>
                <a:xfrm>
                  <a:off x="517245" y="3003345"/>
                  <a:ext cx="490840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000" b="1" dirty="0">
                      <a:solidFill>
                        <a:srgbClr val="00942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1000" b="1" dirty="0">
                      <a:solidFill>
                        <a:srgbClr val="00942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gal</a:t>
                  </a:r>
                </a:p>
                <a:p>
                  <a:endParaRPr lang="en-US" sz="1000" b="1" dirty="0">
                    <a:solidFill>
                      <a:srgbClr val="009424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13A1BDE-BA0D-8194-E4A7-BFC038AEECCF}"/>
                  </a:ext>
                </a:extLst>
              </p:cNvPr>
              <p:cNvSpPr txBox="1"/>
              <p:nvPr/>
            </p:nvSpPr>
            <p:spPr>
              <a:xfrm>
                <a:off x="243768" y="1349388"/>
                <a:ext cx="3113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5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1BCE20B3-5D17-A11F-E990-2A198F28C92E}"/>
                  </a:ext>
                </a:extLst>
              </p:cNvPr>
              <p:cNvSpPr txBox="1"/>
              <p:nvPr/>
            </p:nvSpPr>
            <p:spPr>
              <a:xfrm>
                <a:off x="243768" y="2435022"/>
                <a:ext cx="3690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15</a:t>
                </a:r>
              </a:p>
            </p:txBody>
          </p:sp>
        </p:grp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4EE1B6F-A988-C152-C552-71283F5675E9}"/>
                </a:ext>
              </a:extLst>
            </p:cNvPr>
            <p:cNvSpPr txBox="1"/>
            <p:nvPr/>
          </p:nvSpPr>
          <p:spPr>
            <a:xfrm>
              <a:off x="329744" y="3772999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5699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590fea8-b43e-4be5-abf1-9cc087fb0ca9">
      <Terms xmlns="http://schemas.microsoft.com/office/infopath/2007/PartnerControls"/>
    </lcf76f155ced4ddcb4097134ff3c332f>
    <TaxCatchAll xmlns="6de238ee-0c3b-46c4-ae48-b7b3be2bec59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AE2816E44124D4EAC50EE55289EDB1B" ma:contentTypeVersion="19" ma:contentTypeDescription="Create a new document." ma:contentTypeScope="" ma:versionID="0d707843d587655ba6415dd1c23ad60e">
  <xsd:schema xmlns:xsd="http://www.w3.org/2001/XMLSchema" xmlns:xs="http://www.w3.org/2001/XMLSchema" xmlns:p="http://schemas.microsoft.com/office/2006/metadata/properties" xmlns:ns2="e590fea8-b43e-4be5-abf1-9cc087fb0ca9" xmlns:ns3="6de238ee-0c3b-46c4-ae48-b7b3be2bec59" targetNamespace="http://schemas.microsoft.com/office/2006/metadata/properties" ma:root="true" ma:fieldsID="4dd8490b6f45310af4ffbb9ade782522" ns2:_="" ns3:_="">
    <xsd:import namespace="e590fea8-b43e-4be5-abf1-9cc087fb0ca9"/>
    <xsd:import namespace="6de238ee-0c3b-46c4-ae48-b7b3be2bec5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Location" minOccurs="0"/>
                <xsd:element ref="ns2:MediaServiceOCR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90fea8-b43e-4be5-abf1-9cc087fb0ca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28b28469-8996-4088-bd89-44d87d6385e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de238ee-0c3b-46c4-ae48-b7b3be2bec59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ff48ad4f-232c-44c2-aeae-7cfe56513bcc}" ma:internalName="TaxCatchAll" ma:showField="CatchAllData" ma:web="6de238ee-0c3b-46c4-ae48-b7b3be2bec5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43233D60-3A9C-4BC9-A9E8-B8D38FE8EB71}">
  <ds:schemaRefs>
    <ds:schemaRef ds:uri="http://purl.org/dc/terms/"/>
    <ds:schemaRef ds:uri="6de238ee-0c3b-46c4-ae48-b7b3be2bec59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http://www.w3.org/XML/1998/namespace"/>
    <ds:schemaRef ds:uri="e590fea8-b43e-4be5-abf1-9cc087fb0ca9"/>
  </ds:schemaRefs>
</ds:datastoreItem>
</file>

<file path=customXml/itemProps2.xml><?xml version="1.0" encoding="utf-8"?>
<ds:datastoreItem xmlns:ds="http://schemas.openxmlformats.org/officeDocument/2006/customXml" ds:itemID="{C27A6FB7-EE2C-4BC1-807E-0C6E59B58F0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590fea8-b43e-4be5-abf1-9cc087fb0ca9"/>
    <ds:schemaRef ds:uri="6de238ee-0c3b-46c4-ae48-b7b3be2bec5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2FDEE06-A93A-4488-8C65-73D7EAB0F1A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90</TotalTime>
  <Words>254</Words>
  <Application>Microsoft Office PowerPoint</Application>
  <PresentationFormat>Letter Paper (8.5x11 in)</PresentationFormat>
  <Paragraphs>58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mbria Math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 Han</dc:creator>
  <cp:lastModifiedBy>Lei, Yuguo</cp:lastModifiedBy>
  <cp:revision>6</cp:revision>
  <cp:lastPrinted>2025-07-24T14:16:02Z</cp:lastPrinted>
  <dcterms:created xsi:type="dcterms:W3CDTF">2025-07-22T17:48:23Z</dcterms:created>
  <dcterms:modified xsi:type="dcterms:W3CDTF">2025-07-24T15:15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AE2816E44124D4EAC50EE55289EDB1B</vt:lpwstr>
  </property>
  <property fmtid="{D5CDD505-2E9C-101B-9397-08002B2CF9AE}" pid="3" name="MediaServiceImageTags">
    <vt:lpwstr/>
  </property>
</Properties>
</file>